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6E2E8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712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696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741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679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215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250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96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50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753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161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117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A648A-D2C4-421E-8E13-E4508B75C161}" type="datetimeFigureOut">
              <a:rPr lang="en-US" smtClean="0"/>
              <a:t>1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526921-5162-4170-B890-54125C31DA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481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/>
          <p:cNvSpPr txBox="1"/>
          <p:nvPr/>
        </p:nvSpPr>
        <p:spPr>
          <a:xfrm>
            <a:off x="8570904" y="1351070"/>
            <a:ext cx="2749626" cy="3256227"/>
          </a:xfrm>
          <a:prstGeom prst="rect">
            <a:avLst/>
          </a:prstGeom>
          <a:solidFill>
            <a:schemeClr val="bg1">
              <a:lumMod val="95000"/>
            </a:schemeClr>
          </a:solidFill>
          <a:effectLst>
            <a:glow rad="228600">
              <a:schemeClr val="accent3">
                <a:satMod val="175000"/>
                <a:alpha val="40000"/>
              </a:schemeClr>
            </a:glow>
          </a:effectLst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49" name="TextBox 48"/>
          <p:cNvSpPr txBox="1"/>
          <p:nvPr/>
        </p:nvSpPr>
        <p:spPr>
          <a:xfrm>
            <a:off x="862885" y="1365161"/>
            <a:ext cx="7328078" cy="3300298"/>
          </a:xfrm>
          <a:prstGeom prst="rect">
            <a:avLst/>
          </a:prstGeom>
          <a:solidFill>
            <a:schemeClr val="bg1">
              <a:lumMod val="85000"/>
            </a:schemeClr>
          </a:solidFill>
          <a:effectLst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024943" y="995829"/>
            <a:ext cx="2246291" cy="369332"/>
          </a:xfrm>
          <a:prstGeom prst="rect">
            <a:avLst/>
          </a:prstGeom>
          <a:solidFill>
            <a:srgbClr val="C6E2E8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>
                <a:ln>
                  <a:solidFill>
                    <a:schemeClr val="tx1"/>
                  </a:solidFill>
                </a:ln>
              </a:rPr>
              <a:t>Cause of attrition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79145" y="295151"/>
            <a:ext cx="3212204" cy="519351"/>
          </a:xfrm>
          <a:prstGeom prst="ellipse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smtClean="0">
                <a:ln>
                  <a:solidFill>
                    <a:schemeClr val="tx1"/>
                  </a:solidFill>
                </a:ln>
              </a:rPr>
              <a:t>Initial Enrolment</a:t>
            </a:r>
            <a:r>
              <a:rPr lang="en-US" dirty="0" smtClean="0">
                <a:ln>
                  <a:solidFill>
                    <a:schemeClr val="tx1"/>
                  </a:solidFill>
                </a:ln>
                <a:solidFill>
                  <a:srgbClr val="FF0000"/>
                </a:solidFill>
              </a:rPr>
              <a:t> (234)</a:t>
            </a:r>
            <a:endParaRPr lang="en-US" dirty="0">
              <a:ln>
                <a:solidFill>
                  <a:schemeClr val="tx1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130103" y="4660073"/>
            <a:ext cx="1094704" cy="519351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i="1" dirty="0" smtClean="0">
                <a:ln>
                  <a:solidFill>
                    <a:schemeClr val="tx1"/>
                  </a:solidFill>
                </a:ln>
              </a:rPr>
              <a:t>Total</a:t>
            </a:r>
            <a:endParaRPr lang="en-US" i="1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31383" y="5176581"/>
            <a:ext cx="7307700" cy="369332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liberately withdrawn to equalize number with career women </a:t>
            </a:r>
            <a:r>
              <a:rPr lang="en-GB" b="1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3, 1.3%)</a:t>
            </a:r>
            <a:endParaRPr lang="en-US" b="1" dirty="0">
              <a:ln>
                <a:solidFill>
                  <a:schemeClr val="tx1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176530" y="5598610"/>
            <a:ext cx="3044780" cy="605909"/>
          </a:xfrm>
          <a:prstGeom prst="flowChartTerminator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200" dirty="0" smtClean="0">
                <a:ln>
                  <a:solidFill>
                    <a:schemeClr val="tx1"/>
                  </a:solidFill>
                </a:ln>
              </a:rPr>
              <a:t>Net total </a:t>
            </a:r>
            <a:r>
              <a:rPr lang="en-US" sz="2200" dirty="0" smtClean="0">
                <a:ln>
                  <a:solidFill>
                    <a:schemeClr val="tx1"/>
                  </a:solidFill>
                </a:ln>
                <a:solidFill>
                  <a:srgbClr val="FF0000"/>
                </a:solidFill>
              </a:rPr>
              <a:t>(208, 88.9%)</a:t>
            </a:r>
            <a:endParaRPr lang="en-US" sz="2200" dirty="0">
              <a:ln>
                <a:solidFill>
                  <a:schemeClr val="tx1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19254" y="6302165"/>
            <a:ext cx="6914887" cy="40011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dirty="0" smtClean="0">
                <a:ln>
                  <a:solidFill>
                    <a:schemeClr val="tx1"/>
                  </a:solidFill>
                </a:ln>
              </a:rPr>
              <a:t>Figure i: Flow chart showing attrition of women in the study</a:t>
            </a:r>
            <a:endParaRPr lang="en-US" sz="2000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830352" y="321174"/>
            <a:ext cx="180304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Employed (117)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712574" y="1479860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2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8712574" y="1950146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2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712574" y="2437328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1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8712574" y="2902267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---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712574" y="3713343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3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714721" y="4202809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5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558025" y="4636466"/>
            <a:ext cx="961613" cy="519351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i="1" dirty="0" smtClean="0">
                <a:ln>
                  <a:solidFill>
                    <a:schemeClr val="tx1"/>
                  </a:solidFill>
                </a:ln>
                <a:solidFill>
                  <a:srgbClr val="FF0000"/>
                </a:solidFill>
              </a:rPr>
              <a:t>104</a:t>
            </a:r>
            <a:endParaRPr lang="en-US" i="1" dirty="0">
              <a:ln>
                <a:solidFill>
                  <a:schemeClr val="tx1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712574" y="5181810"/>
            <a:ext cx="6782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---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9760036" y="321174"/>
            <a:ext cx="203486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Unemployed (117)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570904" y="5615536"/>
            <a:ext cx="946581" cy="649188"/>
          </a:xfrm>
          <a:prstGeom prst="flowChartTerminator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>
                <a:ln>
                  <a:solidFill>
                    <a:schemeClr val="tx1"/>
                  </a:solidFill>
                </a:ln>
              </a:rPr>
              <a:t>104</a:t>
            </a:r>
            <a:endParaRPr lang="en-US" sz="2400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0410432" y="1479860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3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0410432" y="1950146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5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0410432" y="3716976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---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0410432" y="2441621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1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0410432" y="4202809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---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0410432" y="2896399"/>
            <a:ext cx="678284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1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0410432" y="5181810"/>
            <a:ext cx="6782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n>
                  <a:solidFill>
                    <a:schemeClr val="tx1"/>
                  </a:solidFill>
                </a:ln>
              </a:rPr>
              <a:t>3</a:t>
            </a:r>
            <a:endParaRPr lang="en-US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0255883" y="4636220"/>
            <a:ext cx="961613" cy="519351"/>
          </a:xfrm>
          <a:prstGeom prst="ellipse">
            <a:avLst/>
          </a:prstGeom>
          <a:noFill/>
          <a:ln w="285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i="1" dirty="0" smtClean="0">
                <a:ln>
                  <a:solidFill>
                    <a:schemeClr val="tx1"/>
                  </a:solidFill>
                </a:ln>
                <a:solidFill>
                  <a:srgbClr val="FF0000"/>
                </a:solidFill>
              </a:rPr>
              <a:t>107</a:t>
            </a:r>
            <a:endParaRPr lang="en-US" i="1" dirty="0">
              <a:ln>
                <a:solidFill>
                  <a:schemeClr val="tx1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0268762" y="5598610"/>
            <a:ext cx="946581" cy="649188"/>
          </a:xfrm>
          <a:prstGeom prst="flowChartTerminator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400" dirty="0" smtClean="0">
                <a:ln>
                  <a:solidFill>
                    <a:schemeClr val="tx1"/>
                  </a:solidFill>
                </a:ln>
              </a:rPr>
              <a:t>104</a:t>
            </a:r>
            <a:endParaRPr lang="en-US" sz="2400" dirty="0">
              <a:ln>
                <a:solidFill>
                  <a:schemeClr val="tx1"/>
                </a:solidFill>
              </a:ln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24944" y="1479860"/>
            <a:ext cx="4757670" cy="36933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clined to participate in the follow-up </a:t>
            </a:r>
            <a:r>
              <a:rPr lang="en-GB" b="1" dirty="0" smtClean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5, 2.1%)</a:t>
            </a:r>
            <a:endParaRPr lang="en-US" b="1" dirty="0">
              <a:ln>
                <a:solidFill>
                  <a:schemeClr val="tx1"/>
                </a:solidFill>
              </a:ln>
              <a:solidFill>
                <a:srgbClr val="C0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24943" y="1950146"/>
            <a:ext cx="6959957" cy="36933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uld not be traced with address and phone number given </a:t>
            </a:r>
            <a:r>
              <a:rPr lang="en-GB" b="1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7, 3.0%)</a:t>
            </a:r>
            <a:endParaRPr lang="en-US" b="1" dirty="0">
              <a:ln>
                <a:solidFill>
                  <a:schemeClr val="tx1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31382" y="2437328"/>
            <a:ext cx="4635322" cy="36933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st baby before completion of </a:t>
            </a:r>
            <a:r>
              <a:rPr lang="en-GB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y </a:t>
            </a:r>
            <a:r>
              <a:rPr lang="en-GB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b="1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, 0.9%)</a:t>
            </a:r>
            <a:endParaRPr lang="en-US" b="1" dirty="0">
              <a:ln>
                <a:solidFill>
                  <a:schemeClr val="tx1"/>
                </a:solidFill>
              </a:ln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031383" y="2928527"/>
            <a:ext cx="6026240" cy="646331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oved home without informing researchers and/or research assistant and could not be contacted on phone </a:t>
            </a:r>
            <a:r>
              <a:rPr lang="en-GB" b="1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1, 0.4%)</a:t>
            </a:r>
            <a:endParaRPr lang="en-US" b="1" dirty="0">
              <a:ln>
                <a:solidFill>
                  <a:schemeClr val="tx1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31383" y="3713343"/>
            <a:ext cx="5626994" cy="36933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sumed work before 12 weeks post delivery </a:t>
            </a:r>
            <a:r>
              <a:rPr lang="en-GB" b="1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3, 1.3%)</a:t>
            </a:r>
            <a:endParaRPr lang="en-US" b="1" dirty="0">
              <a:ln>
                <a:solidFill>
                  <a:schemeClr val="tx1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31383" y="4180202"/>
            <a:ext cx="4944414" cy="369332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id not resume work after 12 weeks </a:t>
            </a:r>
            <a:r>
              <a:rPr lang="en-GB" b="1" dirty="0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5, 2.1%)</a:t>
            </a:r>
            <a:endParaRPr lang="en-US" b="1" dirty="0">
              <a:ln>
                <a:solidFill>
                  <a:schemeClr val="tx1"/>
                </a:solidFill>
              </a:ln>
              <a:solidFill>
                <a:srgbClr val="FF0000"/>
              </a:solidFill>
            </a:endParaRPr>
          </a:p>
        </p:txBody>
      </p:sp>
      <p:cxnSp>
        <p:nvCxnSpPr>
          <p:cNvPr id="48" name="Straight Connector 47"/>
          <p:cNvCxnSpPr/>
          <p:nvPr/>
        </p:nvCxnSpPr>
        <p:spPr>
          <a:xfrm flipH="1">
            <a:off x="3693554" y="5483388"/>
            <a:ext cx="6439" cy="160781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8126568" y="3015310"/>
            <a:ext cx="367062" cy="11225"/>
          </a:xfrm>
          <a:prstGeom prst="line">
            <a:avLst/>
          </a:prstGeom>
          <a:ln w="28575"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flipH="1">
            <a:off x="502277" y="554189"/>
            <a:ext cx="28444" cy="533145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>
            <a:off x="502276" y="4919730"/>
            <a:ext cx="2472744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476518" y="5885644"/>
            <a:ext cx="1609859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530721" y="554189"/>
            <a:ext cx="548425" cy="63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9015211" y="690506"/>
            <a:ext cx="0" cy="660564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10764591" y="690506"/>
            <a:ext cx="0" cy="660564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89440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148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5</cp:revision>
  <dcterms:created xsi:type="dcterms:W3CDTF">2017-08-08T18:52:10Z</dcterms:created>
  <dcterms:modified xsi:type="dcterms:W3CDTF">2018-01-04T16:11:43Z</dcterms:modified>
</cp:coreProperties>
</file>